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9" d="100"/>
          <a:sy n="79" d="100"/>
        </p:scale>
        <p:origin x="773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rco Maria Germani" userId="5fff2a9a-bd7d-4fda-8656-98266a06616d" providerId="ADAL" clId="{B59156BC-4F96-4DA7-AC52-70E4E9FE1FB8}"/>
    <pc:docChg chg="delSld modSld">
      <pc:chgData name="Marco Maria Germani" userId="5fff2a9a-bd7d-4fda-8656-98266a06616d" providerId="ADAL" clId="{B59156BC-4F96-4DA7-AC52-70E4E9FE1FB8}" dt="2024-03-07T22:26:19.053" v="4" actId="20577"/>
      <pc:docMkLst>
        <pc:docMk/>
      </pc:docMkLst>
      <pc:sldChg chg="modSp mod">
        <pc:chgData name="Marco Maria Germani" userId="5fff2a9a-bd7d-4fda-8656-98266a06616d" providerId="ADAL" clId="{B59156BC-4F96-4DA7-AC52-70E4E9FE1FB8}" dt="2024-03-07T22:26:19.053" v="4" actId="20577"/>
        <pc:sldMkLst>
          <pc:docMk/>
          <pc:sldMk cId="3929295306" sldId="256"/>
        </pc:sldMkLst>
        <pc:spChg chg="mod">
          <ac:chgData name="Marco Maria Germani" userId="5fff2a9a-bd7d-4fda-8656-98266a06616d" providerId="ADAL" clId="{B59156BC-4F96-4DA7-AC52-70E4E9FE1FB8}" dt="2024-03-07T22:26:19.053" v="4" actId="20577"/>
          <ac:spMkLst>
            <pc:docMk/>
            <pc:sldMk cId="3929295306" sldId="256"/>
            <ac:spMk id="13" creationId="{E9108528-881E-DCE5-DA41-42A8D1B7A8A8}"/>
          </ac:spMkLst>
        </pc:spChg>
      </pc:sldChg>
      <pc:sldChg chg="del">
        <pc:chgData name="Marco Maria Germani" userId="5fff2a9a-bd7d-4fda-8656-98266a06616d" providerId="ADAL" clId="{B59156BC-4F96-4DA7-AC52-70E4E9FE1FB8}" dt="2024-02-28T23:33:27.999" v="0" actId="47"/>
        <pc:sldMkLst>
          <pc:docMk/>
          <pc:sldMk cId="1133130057" sldId="257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34878C2-0B97-1A6F-08C9-840CEEA00EB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1820B300-7CFB-0968-E8B0-0AD44B2153D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154F67B-2644-50E5-DB2C-92E5C00D4E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4E3D0-A17D-45C4-8631-4EFBB12956DF}" type="datetimeFigureOut">
              <a:rPr lang="it-IT" smtClean="0"/>
              <a:t>07/03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0A2C0A1-652E-DC55-FDBA-1F7D690B7D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E34D09B-A999-5C4F-D7D9-7569E462D6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40078-C50C-4707-9456-CC0D630BEB0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827047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BEC3044-69A0-CCE1-FD79-42B90F83B7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A75C3A3B-FEEB-678F-8CAB-9BBDE3AE4A8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F1DFAC5-9F91-48BC-61C0-3B1CB8D869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4E3D0-A17D-45C4-8631-4EFBB12956DF}" type="datetimeFigureOut">
              <a:rPr lang="it-IT" smtClean="0"/>
              <a:t>07/03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1DF5DFA-AF5A-C13B-C77A-650EBB842E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E002B84-ACC0-0BA5-7128-F05AA9B992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40078-C50C-4707-9456-CC0D630BEB0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330559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962C0977-5280-E511-1E1D-A05A7F225FF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C8834A2A-62FF-6800-8B13-B80C226C636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43CCDAC-5C64-1E85-8BBB-B51D856A42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4E3D0-A17D-45C4-8631-4EFBB12956DF}" type="datetimeFigureOut">
              <a:rPr lang="it-IT" smtClean="0"/>
              <a:t>07/03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4348D20-81D5-F5EB-4F87-5961DF2F8D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94079E7-1627-2D8D-7BAB-8AA5CE1B3B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40078-C50C-4707-9456-CC0D630BEB0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802148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2E81187-397B-1A34-B307-AC9FF1D57C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3BD7888A-6435-2C68-E7F9-6C1B43610DA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E796452-91AE-70EE-3763-B206DA7F87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4E3D0-A17D-45C4-8631-4EFBB12956DF}" type="datetimeFigureOut">
              <a:rPr lang="it-IT" smtClean="0"/>
              <a:t>07/03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2E88FFA-89E0-81E2-F949-6705805057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68E22A6-8D83-B44E-E9EB-1726813938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40078-C50C-4707-9456-CC0D630BEB0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572909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034F1EF-8E1E-7E91-1350-6DFE33802C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52AD9981-C333-DC1C-DF0C-5AD63F827C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1594866-E266-BE07-CB7E-5B22A27AF7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4E3D0-A17D-45C4-8631-4EFBB12956DF}" type="datetimeFigureOut">
              <a:rPr lang="it-IT" smtClean="0"/>
              <a:t>07/03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590A93D-1E55-8E59-73ED-C4660B533C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45F0620-96A4-8B03-0E1E-B723DEF08A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40078-C50C-4707-9456-CC0D630BEB0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3066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AD83640-DA26-F2CC-ED8C-B1E0E19D12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F76927E4-1B8A-3FBD-EAFB-FD423B77FFF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EF533FB0-8EAD-8934-F80B-EF5E822625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9B1A0546-08BD-5AB4-F896-683B3BE4DD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4E3D0-A17D-45C4-8631-4EFBB12956DF}" type="datetimeFigureOut">
              <a:rPr lang="it-IT" smtClean="0"/>
              <a:t>07/03/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D09DE328-AE99-5AA1-A6B1-0FA4F30A9A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4A50BBEE-9C56-02EC-99A0-51564DFB25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40078-C50C-4707-9456-CC0D630BEB0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104561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3509E00-7925-BD56-7BE3-87579A8475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20A8DC84-7D79-4F05-E9DE-EDF6012544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C91A171E-A10D-FC7F-8BE9-E8DC343417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518E5956-9906-7D48-CAB5-63A5C274CCF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8E892352-5496-2C6A-A249-D51F85430A4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AC99DF3E-2CA3-ECD8-FB4B-D2D94A935E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4E3D0-A17D-45C4-8631-4EFBB12956DF}" type="datetimeFigureOut">
              <a:rPr lang="it-IT" smtClean="0"/>
              <a:t>07/03/24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EEE949BD-3EE3-EA6E-3FF0-95885E9342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749A8124-A257-0213-43F6-980ECD804C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40078-C50C-4707-9456-CC0D630BEB0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051504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93FC241-89FD-B393-3D88-6CA2AFFBDD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5A3FAAC8-21B2-CABA-6A7C-B3F523A39C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4E3D0-A17D-45C4-8631-4EFBB12956DF}" type="datetimeFigureOut">
              <a:rPr lang="it-IT" smtClean="0"/>
              <a:t>07/03/24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318ABB88-14E4-CFD8-A0CA-6F500EB11C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8D07CCBD-3B93-3F00-828E-C5EC55EFD1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40078-C50C-4707-9456-CC0D630BEB0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631321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CD9E109F-F790-D5CF-9C59-F539A27712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4E3D0-A17D-45C4-8631-4EFBB12956DF}" type="datetimeFigureOut">
              <a:rPr lang="it-IT" smtClean="0"/>
              <a:t>07/03/24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D59DA810-C010-6C85-55AB-6820DE48D6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F4AF9113-2E0A-A3C1-8D1E-96EC97E29B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40078-C50C-4707-9456-CC0D630BEB0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487599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A9DF60B-0987-67A0-CFBC-8329480807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76CFEC5-48FD-4900-0561-1F2447211C8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BC1CB685-913F-0972-C93A-BA725A74E1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21FB063D-F8B4-BF62-4F58-5F50EA132D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4E3D0-A17D-45C4-8631-4EFBB12956DF}" type="datetimeFigureOut">
              <a:rPr lang="it-IT" smtClean="0"/>
              <a:t>07/03/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014DCD6A-4F45-57A9-817E-327EC6D134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4B09E62E-2B10-73FD-85DD-A85DCDF878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40078-C50C-4707-9456-CC0D630BEB0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709128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4CF758F-84A3-F209-EE77-F30845BB86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3860A78D-C596-8795-B871-87BC073303F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1964C440-E8E2-529F-84FF-E49D741415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E932AF76-C099-7560-2C7D-611D43FA5B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4E3D0-A17D-45C4-8631-4EFBB12956DF}" type="datetimeFigureOut">
              <a:rPr lang="it-IT" smtClean="0"/>
              <a:t>07/03/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20D0AA6C-6BDB-749E-8484-BCC2375E35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3B6E764E-B352-C7B8-058F-5E953171A1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40078-C50C-4707-9456-CC0D630BEB0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377232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6FFFDE11-4363-96DD-6884-4BA56EBF0B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A652ADC-B730-2671-C7C1-55460684A9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01CDBDD-12F1-96C9-0A67-87ECB60DB55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34E3D0-A17D-45C4-8631-4EFBB12956DF}" type="datetimeFigureOut">
              <a:rPr lang="it-IT" smtClean="0"/>
              <a:t>07/03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A1E4573-78D2-66A5-85A0-1FEDB47C6C3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3625E1A-317A-4AC3-A051-BFEB0D4801F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340078-C50C-4707-9456-CC0D630BEB0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924188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>
            <a:extLst>
              <a:ext uri="{FF2B5EF4-FFF2-40B4-BE49-F238E27FC236}">
                <a16:creationId xmlns:a16="http://schemas.microsoft.com/office/drawing/2014/main" id="{933C95CA-E7DB-37B6-190C-226574D0D94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45372" y="454260"/>
            <a:ext cx="7713028" cy="5787979"/>
          </a:xfrm>
          <a:prstGeom prst="rect">
            <a:avLst/>
          </a:prstGeom>
        </p:spPr>
      </p:pic>
      <p:sp>
        <p:nvSpPr>
          <p:cNvPr id="6" name="object 84">
            <a:extLst>
              <a:ext uri="{FF2B5EF4-FFF2-40B4-BE49-F238E27FC236}">
                <a16:creationId xmlns:a16="http://schemas.microsoft.com/office/drawing/2014/main" id="{6F2E49C5-885B-BB6E-14B5-E4A6F0022EE6}"/>
              </a:ext>
            </a:extLst>
          </p:cNvPr>
          <p:cNvSpPr txBox="1"/>
          <p:nvPr/>
        </p:nvSpPr>
        <p:spPr>
          <a:xfrm>
            <a:off x="8870186" y="851284"/>
            <a:ext cx="1683412" cy="328935"/>
          </a:xfrm>
          <a:prstGeom prst="rect">
            <a:avLst/>
          </a:prstGeom>
        </p:spPr>
        <p:txBody>
          <a:bodyPr vert="horz" wrap="square" lIns="0" tIns="26034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4"/>
              </a:spcBef>
            </a:pPr>
            <a:r>
              <a:rPr lang="it-IT" sz="900" spc="20" dirty="0">
                <a:latin typeface="Arial" panose="020B0604020202020204" pitchFamily="34" charset="0"/>
                <a:cs typeface="Arial" panose="020B0604020202020204" pitchFamily="34" charset="0"/>
              </a:rPr>
              <a:t>60.3 (42.1-72.2)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2700">
              <a:lnSpc>
                <a:spcPct val="100000"/>
              </a:lnSpc>
              <a:spcBef>
                <a:spcPts val="204"/>
              </a:spcBef>
            </a:pPr>
            <a:r>
              <a:rPr lang="it-IT" sz="900" spc="20" dirty="0">
                <a:latin typeface="Arial" panose="020B0604020202020204" pitchFamily="34" charset="0"/>
                <a:cs typeface="Arial" panose="020B0604020202020204" pitchFamily="34" charset="0"/>
              </a:rPr>
              <a:t>19.1 (14.8-21.8)</a:t>
            </a:r>
            <a:endParaRPr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object 87">
            <a:extLst>
              <a:ext uri="{FF2B5EF4-FFF2-40B4-BE49-F238E27FC236}">
                <a16:creationId xmlns:a16="http://schemas.microsoft.com/office/drawing/2014/main" id="{36D84F3E-8EB4-5E45-C13C-CB1B3FD07311}"/>
              </a:ext>
            </a:extLst>
          </p:cNvPr>
          <p:cNvSpPr txBox="1"/>
          <p:nvPr/>
        </p:nvSpPr>
        <p:spPr>
          <a:xfrm>
            <a:off x="5709276" y="870266"/>
            <a:ext cx="2980559" cy="316111"/>
          </a:xfrm>
          <a:prstGeom prst="rect">
            <a:avLst/>
          </a:prstGeom>
        </p:spPr>
        <p:txBody>
          <a:bodyPr vert="horz" wrap="square" lIns="0" tIns="26034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4"/>
              </a:spcBef>
            </a:pPr>
            <a:r>
              <a:rPr lang="it-IT" sz="900" spc="15" dirty="0">
                <a:latin typeface="Arial" panose="020B0604020202020204" pitchFamily="34" charset="0"/>
                <a:cs typeface="Arial" panose="020B0604020202020204" pitchFamily="34" charset="0"/>
              </a:rPr>
              <a:t>     Yes</a:t>
            </a:r>
            <a:r>
              <a:rPr sz="900" spc="1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900" spc="150" dirty="0">
                <a:latin typeface="Arial" panose="020B0604020202020204" pitchFamily="34" charset="0"/>
                <a:cs typeface="Arial" panose="020B0604020202020204" pitchFamily="34" charset="0"/>
              </a:rPr>
              <a:t>                </a:t>
            </a:r>
            <a:r>
              <a:rPr sz="900" spc="30" dirty="0">
                <a:latin typeface="Arial" panose="020B0604020202020204" pitchFamily="34" charset="0"/>
                <a:cs typeface="Arial" panose="020B0604020202020204" pitchFamily="34" charset="0"/>
              </a:rPr>
              <a:t>0.</a:t>
            </a:r>
            <a:r>
              <a:rPr lang="it-IT" sz="900" spc="30" dirty="0">
                <a:latin typeface="Arial" panose="020B0604020202020204" pitchFamily="34" charset="0"/>
                <a:cs typeface="Arial" panose="020B0604020202020204" pitchFamily="34" charset="0"/>
              </a:rPr>
              <a:t>19 (0.13-0.29)</a:t>
            </a:r>
            <a:endParaRPr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2700">
              <a:lnSpc>
                <a:spcPct val="100000"/>
              </a:lnSpc>
              <a:spcBef>
                <a:spcPts val="105"/>
              </a:spcBef>
              <a:tabLst>
                <a:tab pos="286385" algn="l"/>
              </a:tabLst>
            </a:pPr>
            <a:r>
              <a:rPr lang="it-IT" sz="900" spc="25" dirty="0">
                <a:latin typeface="Arial" panose="020B0604020202020204" pitchFamily="34" charset="0"/>
                <a:cs typeface="Arial" panose="020B0604020202020204" pitchFamily="34" charset="0"/>
              </a:rPr>
              <a:t>     No                              </a:t>
            </a:r>
            <a:r>
              <a:rPr sz="900" spc="5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sz="900" spc="30" dirty="0">
                <a:latin typeface="Arial" panose="020B0604020202020204" pitchFamily="34" charset="0"/>
                <a:cs typeface="Arial" panose="020B0604020202020204" pitchFamily="34" charset="0"/>
              </a:rPr>
              <a:t>eference</a:t>
            </a:r>
            <a:endParaRPr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object 88">
            <a:extLst>
              <a:ext uri="{FF2B5EF4-FFF2-40B4-BE49-F238E27FC236}">
                <a16:creationId xmlns:a16="http://schemas.microsoft.com/office/drawing/2014/main" id="{5A673785-EBC2-47DA-3A0E-C6B433864B6C}"/>
              </a:ext>
            </a:extLst>
          </p:cNvPr>
          <p:cNvSpPr txBox="1"/>
          <p:nvPr/>
        </p:nvSpPr>
        <p:spPr>
          <a:xfrm>
            <a:off x="5848401" y="520270"/>
            <a:ext cx="4504639" cy="305212"/>
          </a:xfrm>
          <a:prstGeom prst="rect">
            <a:avLst/>
          </a:prstGeom>
        </p:spPr>
        <p:txBody>
          <a:bodyPr vert="horz" wrap="square" lIns="0" tIns="152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20"/>
              </a:spcBef>
              <a:tabLst>
                <a:tab pos="353695" algn="l"/>
                <a:tab pos="871855" algn="l"/>
              </a:tabLst>
            </a:pPr>
            <a:r>
              <a:rPr lang="it-IT" sz="900" b="1" spc="35" dirty="0">
                <a:latin typeface="Arial" panose="020B0604020202020204" pitchFamily="34" charset="0"/>
                <a:cs typeface="Arial" panose="020B0604020202020204" pitchFamily="34" charset="0"/>
              </a:rPr>
              <a:t>LRT after </a:t>
            </a:r>
            <a:r>
              <a:rPr lang="it-IT" sz="900" b="1" spc="35" dirty="0" err="1">
                <a:latin typeface="Arial" panose="020B0604020202020204" pitchFamily="34" charset="0"/>
                <a:cs typeface="Arial" panose="020B0604020202020204" pitchFamily="34" charset="0"/>
              </a:rPr>
              <a:t>disease</a:t>
            </a:r>
            <a:r>
              <a:rPr lang="it-IT" sz="900" b="1" spc="35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sz="900" b="1" spc="15" dirty="0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r>
              <a:rPr sz="900" b="1" spc="10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sz="900" b="1" spc="40" dirty="0">
                <a:latin typeface="Arial" panose="020B0604020202020204" pitchFamily="34" charset="0"/>
                <a:cs typeface="Arial" panose="020B0604020202020204" pitchFamily="34" charset="0"/>
              </a:rPr>
              <a:t>(95%</a:t>
            </a:r>
            <a:r>
              <a:rPr sz="900" b="1" spc="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sz="900" b="1" spc="20" dirty="0">
                <a:latin typeface="Arial" panose="020B0604020202020204" pitchFamily="34" charset="0"/>
                <a:cs typeface="Arial" panose="020B0604020202020204" pitchFamily="34" charset="0"/>
              </a:rPr>
              <a:t>CI)</a:t>
            </a:r>
            <a:r>
              <a:rPr lang="it-IT" sz="900" b="1" spc="20" dirty="0">
                <a:latin typeface="Arial" panose="020B0604020202020204" pitchFamily="34" charset="0"/>
                <a:cs typeface="Arial" panose="020B0604020202020204" pitchFamily="34" charset="0"/>
              </a:rPr>
              <a:t>       </a:t>
            </a:r>
            <a:r>
              <a:rPr sz="900" b="1" spc="30" dirty="0">
                <a:latin typeface="Arial" panose="020B0604020202020204" pitchFamily="34" charset="0"/>
                <a:cs typeface="Arial" panose="020B0604020202020204" pitchFamily="34" charset="0"/>
              </a:rPr>
              <a:t>Events</a:t>
            </a:r>
            <a:r>
              <a:rPr sz="900" b="1" spc="10" dirty="0">
                <a:latin typeface="Arial" panose="020B0604020202020204" pitchFamily="34" charset="0"/>
                <a:cs typeface="Arial" panose="020B0604020202020204" pitchFamily="34" charset="0"/>
              </a:rPr>
              <a:t>/Total </a:t>
            </a:r>
            <a:r>
              <a:rPr lang="it-IT" sz="900" b="1" spc="10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sz="900" b="1" spc="30" dirty="0">
                <a:latin typeface="Arial" panose="020B0604020202020204" pitchFamily="34" charset="0"/>
                <a:cs typeface="Arial" panose="020B0604020202020204" pitchFamily="34" charset="0"/>
              </a:rPr>
              <a:t>Median </a:t>
            </a:r>
            <a:r>
              <a:rPr sz="900" b="1" spc="40" dirty="0">
                <a:latin typeface="Arial" panose="020B0604020202020204" pitchFamily="34" charset="0"/>
                <a:cs typeface="Arial" panose="020B0604020202020204" pitchFamily="34" charset="0"/>
              </a:rPr>
              <a:t>(95%</a:t>
            </a:r>
            <a:r>
              <a:rPr sz="900" b="1" spc="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sz="900" b="1" spc="20" dirty="0">
                <a:latin typeface="Arial" panose="020B0604020202020204" pitchFamily="34" charset="0"/>
                <a:cs typeface="Arial" panose="020B0604020202020204" pitchFamily="34" charset="0"/>
              </a:rPr>
              <a:t>CI)</a:t>
            </a:r>
            <a:endParaRPr lang="it-IT" sz="900" b="1" spc="2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2700">
              <a:lnSpc>
                <a:spcPct val="100000"/>
              </a:lnSpc>
              <a:spcBef>
                <a:spcPts val="120"/>
              </a:spcBef>
              <a:tabLst>
                <a:tab pos="353695" algn="l"/>
                <a:tab pos="871855" algn="l"/>
              </a:tabLst>
            </a:pPr>
            <a:r>
              <a:rPr lang="it-IT" sz="900" b="1" spc="20" dirty="0">
                <a:latin typeface="Arial" panose="020B0604020202020204" pitchFamily="34" charset="0"/>
                <a:cs typeface="Arial" panose="020B0604020202020204" pitchFamily="34" charset="0"/>
              </a:rPr>
              <a:t>relapse</a:t>
            </a:r>
            <a:endParaRPr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0CC9666E-0F45-45FB-74AB-92DEAE6472BE}"/>
              </a:ext>
            </a:extLst>
          </p:cNvPr>
          <p:cNvSpPr txBox="1"/>
          <p:nvPr/>
        </p:nvSpPr>
        <p:spPr>
          <a:xfrm>
            <a:off x="8927885" y="1317877"/>
            <a:ext cx="918743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100" b="1" spc="30" dirty="0">
                <a:latin typeface="Arial" panose="020B0604020202020204" pitchFamily="34" charset="0"/>
                <a:cs typeface="Arial" panose="020B0604020202020204" pitchFamily="34" charset="0"/>
              </a:rPr>
              <a:t>p &lt; 0.0001</a:t>
            </a:r>
            <a:endParaRPr lang="it-IT" sz="1100" dirty="0"/>
          </a:p>
        </p:txBody>
      </p:sp>
      <p:cxnSp>
        <p:nvCxnSpPr>
          <p:cNvPr id="10" name="Connettore diritto 12">
            <a:extLst>
              <a:ext uri="{FF2B5EF4-FFF2-40B4-BE49-F238E27FC236}">
                <a16:creationId xmlns:a16="http://schemas.microsoft.com/office/drawing/2014/main" id="{8666EA45-1573-D4D3-2BE0-C106CD0C8F0E}"/>
              </a:ext>
            </a:extLst>
          </p:cNvPr>
          <p:cNvCxnSpPr>
            <a:cxnSpLocks/>
          </p:cNvCxnSpPr>
          <p:nvPr/>
        </p:nvCxnSpPr>
        <p:spPr>
          <a:xfrm>
            <a:off x="5522843" y="1137289"/>
            <a:ext cx="226416" cy="0"/>
          </a:xfrm>
          <a:prstGeom prst="line">
            <a:avLst/>
          </a:prstGeom>
          <a:ln w="28575">
            <a:solidFill>
              <a:srgbClr val="3333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Connettore diritto 12">
            <a:extLst>
              <a:ext uri="{FF2B5EF4-FFF2-40B4-BE49-F238E27FC236}">
                <a16:creationId xmlns:a16="http://schemas.microsoft.com/office/drawing/2014/main" id="{9D106460-B687-75AD-AA6D-0DA517F5A4BA}"/>
              </a:ext>
            </a:extLst>
          </p:cNvPr>
          <p:cNvCxnSpPr>
            <a:cxnSpLocks/>
          </p:cNvCxnSpPr>
          <p:nvPr/>
        </p:nvCxnSpPr>
        <p:spPr>
          <a:xfrm>
            <a:off x="5522843" y="984946"/>
            <a:ext cx="226416" cy="0"/>
          </a:xfrm>
          <a:prstGeom prst="line">
            <a:avLst/>
          </a:prstGeom>
          <a:ln w="28575">
            <a:solidFill>
              <a:srgbClr val="CC291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object 84">
            <a:extLst>
              <a:ext uri="{FF2B5EF4-FFF2-40B4-BE49-F238E27FC236}">
                <a16:creationId xmlns:a16="http://schemas.microsoft.com/office/drawing/2014/main" id="{E9108528-881E-DCE5-DA41-42A8D1B7A8A8}"/>
              </a:ext>
            </a:extLst>
          </p:cNvPr>
          <p:cNvSpPr txBox="1"/>
          <p:nvPr/>
        </p:nvSpPr>
        <p:spPr>
          <a:xfrm>
            <a:off x="8088631" y="857442"/>
            <a:ext cx="564003" cy="328935"/>
          </a:xfrm>
          <a:prstGeom prst="rect">
            <a:avLst/>
          </a:prstGeom>
        </p:spPr>
        <p:txBody>
          <a:bodyPr vert="horz" wrap="square" lIns="0" tIns="26034" rIns="0" bIns="0" rtlCol="0">
            <a:spAutoFit/>
          </a:bodyPr>
          <a:lstStyle/>
          <a:p>
            <a:pPr marL="12700" algn="ctr">
              <a:lnSpc>
                <a:spcPct val="100000"/>
              </a:lnSpc>
              <a:spcBef>
                <a:spcPts val="204"/>
              </a:spcBef>
            </a:pPr>
            <a:r>
              <a:rPr lang="it-IT" sz="900" spc="20" dirty="0">
                <a:latin typeface="Arial" panose="020B0604020202020204" pitchFamily="34" charset="0"/>
                <a:cs typeface="Arial" panose="020B0604020202020204" pitchFamily="34" charset="0"/>
              </a:rPr>
              <a:t>31/62</a:t>
            </a:r>
          </a:p>
          <a:p>
            <a:pPr marL="12700" algn="ctr">
              <a:spcBef>
                <a:spcPts val="204"/>
              </a:spcBef>
            </a:pPr>
            <a:r>
              <a:rPr lang="it-IT" sz="900" spc="20" dirty="0">
                <a:latin typeface="Arial" panose="020B0604020202020204" pitchFamily="34" charset="0"/>
                <a:cs typeface="Arial" panose="020B0604020202020204" pitchFamily="34" charset="0"/>
              </a:rPr>
              <a:t>87/115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CCEDAEA7-0C19-F2C4-683B-993739EC5E6E}"/>
              </a:ext>
            </a:extLst>
          </p:cNvPr>
          <p:cNvSpPr txBox="1"/>
          <p:nvPr/>
        </p:nvSpPr>
        <p:spPr>
          <a:xfrm>
            <a:off x="3574785" y="6153703"/>
            <a:ext cx="5585904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400" b="1" kern="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Legend:</a:t>
            </a:r>
          </a:p>
          <a:p>
            <a:pPr algn="just"/>
            <a:r>
              <a:rPr lang="en-GB" sz="1400" kern="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CI: confidence interval; HR: hazard ratio; LRT: locoregional treatment</a:t>
            </a:r>
            <a:endParaRPr lang="it-IT" sz="1200" kern="1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2929530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4</TotalTime>
  <Words>58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rco Maria Germani</dc:creator>
  <cp:lastModifiedBy>Marco Maria Germani</cp:lastModifiedBy>
  <cp:revision>2</cp:revision>
  <dcterms:created xsi:type="dcterms:W3CDTF">2024-02-27T22:44:59Z</dcterms:created>
  <dcterms:modified xsi:type="dcterms:W3CDTF">2024-03-07T22:26:25Z</dcterms:modified>
</cp:coreProperties>
</file>